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BC50E-D713-4722-B16E-91C3CC2FBF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B8481-2896-4237-A023-C582BCB718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C159C-2578-45D6-A23F-50A9BF27A2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D3458-DABE-408C-BEAA-8BF57E0D4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F9B9A-BC76-4364-8447-346359E113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AAC65-EEC7-488D-A45C-E5A6EA83FC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ABE80-F764-4D6E-A32E-A923B82AFA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7B6F41-B994-4CF2-AA65-DFB75ACFB8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03C1B-1DE8-40B4-9148-4123725C28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AE66E-60AB-4213-BEE6-50D457FC8F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4865E-A006-471C-83DB-2CF1C58BB6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B7081-FB55-422D-AB4B-7E62A5E4B1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549D84-67BA-4CD3-9DC5-0C2782A6D41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8360" y="692280"/>
          <a:ext cx="8496360" cy="5659200"/>
        </p:xfrm>
        <a:graphic>
          <a:graphicData uri="http://schemas.openxmlformats.org/drawingml/2006/table">
            <a:tbl>
              <a:tblPr/>
              <a:tblGrid>
                <a:gridCol w="392040"/>
                <a:gridCol w="889200"/>
                <a:gridCol w="879480"/>
                <a:gridCol w="595080"/>
                <a:gridCol w="1452600"/>
                <a:gridCol w="1608120"/>
                <a:gridCol w="1228680"/>
                <a:gridCol w="1451160"/>
              </a:tblGrid>
              <a:tr h="3715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umb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numb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ximum fold induction by 20E (induction tim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romoso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caffold position: localization (direction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annotation (or homologous gene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tif of KCRGGTCWWCGMWC (pattern number of 64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omic location of moti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83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27.3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: 3030287-3034921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03571|Snake tox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 : 3020929-3020916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84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8.54 (12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: 1642683-1664614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dehyde oxidas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 : 1675479-1675466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79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6.80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3: 6204504-6207873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ndefin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GGTCTTCGCTC (1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3 : 6233218-6233205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4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129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10.78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4: 1302791-1320850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14021|Helicase superfamily 1 and 2 ATP-binding, IPR001650|Helicase, C-terminal, IPR002464|ATP-dependent helicase, DEAH-box, IPR014001| DEAD-like helicases, N-terminal, IPR007502| Helicase-associated region, IPR011709| Protein of unknown function DUF16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TTCGAAC (64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4 : 1308792-1308805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61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4.79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5: 4300706-4310884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n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GGGTCTACGAAC (28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5 : 4317071-4317058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104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6.51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6: 996537-1013524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06823| Neutral/alkaline nonlysosomal ceramid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6 : 1004780-1004767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73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67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5.27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0: 5971123-5971641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EcR-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GGTCAACGCTC (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0 : 5968090-5968103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67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6.08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0: 5887771-5890919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EcR-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0 : 5859102-5859115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03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37.4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8: 278276-286911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tochrome P450 CYP302A1(Disembodied 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GGTCTTCGAAC (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8 : 277048-277035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696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54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9.48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9: 2473548-2477263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13217| Methyltransferase type 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TCGAAC (5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9 : 2328573-2328586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4"/>
          <p:cNvSpPr/>
          <p:nvPr/>
        </p:nvSpPr>
        <p:spPr>
          <a:xfrm>
            <a:off x="401760" y="260280"/>
            <a:ext cx="797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6. List of 20E-inducible genes identified by microarray analysis and the 14</a:t>
            </a:r>
            <a:r>
              <a:rPr b="0" lang="ja-JP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　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p consensus motif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468360" y="692280"/>
          <a:ext cx="8496360" cy="4176720"/>
        </p:xfrm>
        <a:graphic>
          <a:graphicData uri="http://schemas.openxmlformats.org/drawingml/2006/table">
            <a:tbl>
              <a:tblPr/>
              <a:tblGrid>
                <a:gridCol w="392040"/>
                <a:gridCol w="889200"/>
                <a:gridCol w="879480"/>
                <a:gridCol w="595080"/>
                <a:gridCol w="1452600"/>
                <a:gridCol w="1608120"/>
                <a:gridCol w="1228680"/>
                <a:gridCol w="1451160"/>
              </a:tblGrid>
              <a:tr h="3823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55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8.09 (12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9: 4997351-5006791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eta-glucuronid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GGGTCATCGATC (2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9 : 4966409-4966396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96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477.5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7: 1239351-1239851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HR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7 : 1241267-1241254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6204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19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5.28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8: 590083-607676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10294| ADAM-TS Spacer 1, IPR010909| PLAC, IPR000884| Thrombospondin, type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GGGTCAACGAAC (2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28 : 721699-721712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2404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80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10.73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41: 1880326-1894488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00192| Aminotransferase, class V, IPR005829| Sugar transporter superfamily, IPR000120|Amid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AACGAAC (5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41 : 1892557-1892544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232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68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7.26 (3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70: 19878-25368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E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GGGTCTTCGAAC (64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70 : 35977-35964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860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111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5.65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95: 1143563-1148570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08952| Tetraspanin, IPR000301| CD9/CD37/CD63 antige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GGTCATCGCAC (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95 : 1159517-1159504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6204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5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×4.23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19: 7374-22219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PR003439| ABC transporter related, IPR013525| ABC-2 type transport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AGGTCATCGCTC (37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119 : 54349-54362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2680"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--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GIBMGA0079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x15.18 (24 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3: 6351651-6379668 (+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HR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GGTCTTCGCTC (13)*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_scaf3 : 6233218-6233205 (-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テキスト ボックス 2"/>
          <p:cNvSpPr/>
          <p:nvPr/>
        </p:nvSpPr>
        <p:spPr>
          <a:xfrm>
            <a:off x="406440" y="4941720"/>
            <a:ext cx="159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1: same to the motif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5"/>
          <p:cNvSpPr/>
          <p:nvPr/>
        </p:nvSpPr>
        <p:spPr>
          <a:xfrm>
            <a:off x="394560" y="189000"/>
            <a:ext cx="188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6 - Continu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8T07:12:26Z</dcterms:created>
  <dc:creator> </dc:creator>
  <dc:description/>
  <dc:language>en-US</dc:language>
  <cp:lastModifiedBy> </cp:lastModifiedBy>
  <dcterms:modified xsi:type="dcterms:W3CDTF">2012-05-17T06:14:30Z</dcterms:modified>
  <cp:revision>5</cp:revision>
  <dc:subject/>
  <dc:title>スライド 1</dc:title>
</cp:coreProperties>
</file>